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90EA3-1903-483E-B2C2-B46A072653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F1195-624B-487D-8D0E-C2798307C8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63F3B-5A4B-4411-99AF-36EFDFCEDB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24655-341E-4470-BD1F-0E680A6F37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0FE197-9C3A-403D-9DF7-601CE49528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0247D-D5F3-45F4-861C-B7068B1CEC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ED0DA-9D12-4D75-844B-8B01634EE4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A4C885-B6F6-44F2-B9A9-3851F8A937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E61EBF-DBF3-432D-9371-8E1985B854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540EC0-9E0B-4E57-8C05-19455E3515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96233-6DD8-4CB5-BA2C-B92A1ECF56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F011F-1067-43E0-A06C-310EE4CFDD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038EEB-9E52-4FE1-AA7D-34E6AD82267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411280" y="163656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E1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80000" y="2133720"/>
            <a:ext cx="47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22840" y="488304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KF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401480" y="3124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828880" y="3112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379520" y="4538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840040" y="45356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96680" y="620640"/>
            <a:ext cx="763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Phase contrast              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　　　　　　　　　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Annexin V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　　　　　　　　　　　　　　　　　　　　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83240" y="6302520"/>
            <a:ext cx="27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900000" y="3645000"/>
            <a:ext cx="2559240" cy="255888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2"/>
          <a:stretch/>
        </p:blipFill>
        <p:spPr>
          <a:xfrm>
            <a:off x="6084720" y="3645000"/>
            <a:ext cx="2559240" cy="255888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3"/>
          <a:stretch/>
        </p:blipFill>
        <p:spPr>
          <a:xfrm>
            <a:off x="6084720" y="1014480"/>
            <a:ext cx="2559240" cy="255888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4"/>
          <a:stretch/>
        </p:blipFill>
        <p:spPr>
          <a:xfrm>
            <a:off x="3492360" y="1014480"/>
            <a:ext cx="2559240" cy="255888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5"/>
          <a:stretch/>
        </p:blipFill>
        <p:spPr>
          <a:xfrm>
            <a:off x="900000" y="1014480"/>
            <a:ext cx="2559240" cy="255888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6"/>
          <a:stretch/>
        </p:blipFill>
        <p:spPr>
          <a:xfrm>
            <a:off x="3492360" y="3645000"/>
            <a:ext cx="2559240" cy="2558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"/>
          <p:cNvGrpSpPr/>
          <p:nvPr/>
        </p:nvGrpSpPr>
        <p:grpSpPr>
          <a:xfrm>
            <a:off x="1025640" y="1484280"/>
            <a:ext cx="6859080" cy="3351600"/>
            <a:chOff x="1025640" y="1484280"/>
            <a:chExt cx="6859080" cy="3351600"/>
          </a:xfrm>
        </p:grpSpPr>
        <p:sp>
          <p:nvSpPr>
            <p:cNvPr id="57" name=""/>
            <p:cNvSpPr/>
            <p:nvPr/>
          </p:nvSpPr>
          <p:spPr>
            <a:xfrm>
              <a:off x="1423440" y="1484280"/>
              <a:ext cx="23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811520" y="4653000"/>
              <a:ext cx="797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DAH277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162240" y="4653000"/>
              <a:ext cx="290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S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000680" y="4653000"/>
              <a:ext cx="52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PS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119560" y="4653000"/>
              <a:ext cx="374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KF2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040080" y="4653000"/>
              <a:ext cx="50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OVK1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027560" y="4653000"/>
              <a:ext cx="509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JHOC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6200000">
              <a:off x="11880" y="3111120"/>
              <a:ext cx="2303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ercentage of apoptotic cel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692680" y="2314440"/>
              <a:ext cx="215640" cy="287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692680" y="2746440"/>
              <a:ext cx="215640" cy="28728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892480" y="2335320"/>
              <a:ext cx="1322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ontrol (DMSO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907960" y="2759040"/>
              <a:ext cx="724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I-10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831680" y="1833480"/>
              <a:ext cx="6051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831680" y="1833480"/>
              <a:ext cx="6051240" cy="2681280"/>
            </a:xfrm>
            <a:prstGeom prst="rect">
              <a:avLst/>
            </a:prstGeom>
            <a:noFill/>
            <a:ln w="158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979640" y="4186440"/>
              <a:ext cx="213840" cy="32832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489040" y="2656080"/>
              <a:ext cx="198000" cy="1858680"/>
            </a:xfrm>
            <a:prstGeom prst="rect">
              <a:avLst/>
            </a:prstGeom>
            <a:solidFill>
              <a:srgbClr val="80808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982600" y="4186440"/>
              <a:ext cx="214200" cy="32832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492360" y="2260800"/>
              <a:ext cx="213840" cy="2253960"/>
            </a:xfrm>
            <a:prstGeom prst="rect">
              <a:avLst/>
            </a:prstGeom>
            <a:solidFill>
              <a:srgbClr val="80808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002120" y="3906720"/>
              <a:ext cx="198000" cy="60804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495680" y="2311560"/>
              <a:ext cx="213840" cy="2203200"/>
            </a:xfrm>
            <a:prstGeom prst="rect">
              <a:avLst/>
            </a:prstGeom>
            <a:solidFill>
              <a:srgbClr val="80808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005080" y="4087800"/>
              <a:ext cx="214200" cy="42696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516280" y="4054680"/>
              <a:ext cx="196560" cy="460080"/>
            </a:xfrm>
            <a:prstGeom prst="rect">
              <a:avLst/>
            </a:prstGeom>
            <a:solidFill>
              <a:srgbClr val="80808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6008400" y="4087800"/>
              <a:ext cx="214200" cy="42696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519600" y="3956040"/>
              <a:ext cx="212400" cy="558720"/>
            </a:xfrm>
            <a:prstGeom prst="rect">
              <a:avLst/>
            </a:prstGeom>
            <a:solidFill>
              <a:srgbClr val="80808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7029360" y="4038480"/>
              <a:ext cx="196560" cy="47628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521480" y="3873600"/>
              <a:ext cx="213840" cy="641160"/>
            </a:xfrm>
            <a:prstGeom prst="rect">
              <a:avLst/>
            </a:prstGeom>
            <a:solidFill>
              <a:srgbClr val="80808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2077920" y="3989160"/>
              <a:ext cx="1080" cy="1969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028600" y="3989520"/>
              <a:ext cx="115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2587320" y="2409840"/>
              <a:ext cx="1440" cy="246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538360" y="2409840"/>
              <a:ext cx="115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3081240" y="4087800"/>
              <a:ext cx="1080" cy="98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031920" y="408780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V="1">
              <a:off x="3590640" y="2146320"/>
              <a:ext cx="1440" cy="114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541680" y="2146320"/>
              <a:ext cx="115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4101840" y="3823920"/>
              <a:ext cx="1440" cy="82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051080" y="382428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4593960" y="2161800"/>
              <a:ext cx="1440" cy="149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545000" y="216216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V="1">
              <a:off x="5105160" y="3922200"/>
              <a:ext cx="1440" cy="165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054400" y="392256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V="1">
              <a:off x="5614920" y="3922200"/>
              <a:ext cx="1080" cy="132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565600" y="3922560"/>
              <a:ext cx="11412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V="1">
              <a:off x="6107040" y="3956040"/>
              <a:ext cx="1080" cy="13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6057720" y="395604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6618240" y="3790440"/>
              <a:ext cx="1080" cy="165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6568920" y="3790800"/>
              <a:ext cx="11412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7127640" y="3906720"/>
              <a:ext cx="1440" cy="13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7078680" y="3906720"/>
              <a:ext cx="1137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7621560" y="3839760"/>
              <a:ext cx="1080" cy="33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7572240" y="3840120"/>
              <a:ext cx="11412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077920" y="4186440"/>
              <a:ext cx="1080" cy="196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028600" y="438300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2587320" y="2656080"/>
              <a:ext cx="1440" cy="2473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538360" y="290340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081240" y="4186440"/>
              <a:ext cx="1080" cy="82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031920" y="4268880"/>
              <a:ext cx="115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590640" y="2260800"/>
              <a:ext cx="1440" cy="13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541680" y="2392560"/>
              <a:ext cx="115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101840" y="3906720"/>
              <a:ext cx="1440" cy="65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051080" y="397188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593960" y="2311560"/>
              <a:ext cx="1440" cy="163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545000" y="2475000"/>
              <a:ext cx="115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105160" y="4087800"/>
              <a:ext cx="1440" cy="147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054400" y="4235400"/>
              <a:ext cx="11556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614920" y="4054680"/>
              <a:ext cx="1080" cy="131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565600" y="4186440"/>
              <a:ext cx="11412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6107040" y="4087800"/>
              <a:ext cx="1080" cy="114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057720" y="4202280"/>
              <a:ext cx="1155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6618240" y="3956040"/>
              <a:ext cx="1080" cy="163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568920" y="4119480"/>
              <a:ext cx="11412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127640" y="4038480"/>
              <a:ext cx="1440" cy="114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078680" y="4152960"/>
              <a:ext cx="11376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7621560" y="3873600"/>
              <a:ext cx="1080" cy="489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7572240" y="3922560"/>
              <a:ext cx="114120" cy="18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831680" y="1833480"/>
              <a:ext cx="1440" cy="2681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831680" y="4514760"/>
              <a:ext cx="64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1831680" y="4137120"/>
              <a:ext cx="64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831680" y="3741840"/>
              <a:ext cx="64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831680" y="3363840"/>
              <a:ext cx="64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831680" y="2984400"/>
              <a:ext cx="64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831680" y="2606760"/>
              <a:ext cx="64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831680" y="2211480"/>
              <a:ext cx="648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1831680" y="1833480"/>
              <a:ext cx="64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831680" y="4514760"/>
              <a:ext cx="6051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1831680" y="444996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V="1">
              <a:off x="2341440" y="4449960"/>
              <a:ext cx="108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2835000" y="444996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V="1">
              <a:off x="3344760" y="4449960"/>
              <a:ext cx="108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3854160" y="444996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V="1">
              <a:off x="4348080" y="4449960"/>
              <a:ext cx="108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4857480" y="444996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5367240" y="4449960"/>
              <a:ext cx="108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5860800" y="444996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6370560" y="4449960"/>
              <a:ext cx="108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V="1">
              <a:off x="6879960" y="444996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7373880" y="4449960"/>
              <a:ext cx="108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7883280" y="4449960"/>
              <a:ext cx="1440" cy="64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551240" y="44164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1551240" y="40384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434960" y="36432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1434960" y="32655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434960" y="28861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1434960" y="25081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434960" y="21128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1434960" y="17352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2" name=""/>
          <p:cNvSpPr/>
          <p:nvPr/>
        </p:nvSpPr>
        <p:spPr>
          <a:xfrm>
            <a:off x="183240" y="6302520"/>
            <a:ext cx="27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28T00:55:35Z</dcterms:created>
  <dc:creator>中山</dc:creator>
  <dc:description/>
  <dc:language>en-US</dc:language>
  <cp:lastModifiedBy>k.Narasimhan</cp:lastModifiedBy>
  <dcterms:modified xsi:type="dcterms:W3CDTF">2008-11-13T03:44:15Z</dcterms:modified>
  <cp:revision>98</cp:revision>
  <dc:subject/>
  <dc:title>スライド 1</dc:title>
</cp:coreProperties>
</file>